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5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138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ylor, Christopher A. (CDC/NCIRD/CORVD)" userId="d5235d67-467a-405e-9bf3-737b0972e886" providerId="ADAL" clId="{93021E65-7AAC-4F7E-A208-59245577517D}"/>
    <pc:docChg chg="modSld">
      <pc:chgData name="Taylor, Christopher A. (CDC/NCIRD/CORVD)" userId="d5235d67-467a-405e-9bf3-737b0972e886" providerId="ADAL" clId="{93021E65-7AAC-4F7E-A208-59245577517D}" dt="2024-09-16T19:54:30.419" v="18" actId="20577"/>
      <pc:docMkLst>
        <pc:docMk/>
      </pc:docMkLst>
      <pc:sldChg chg="modSp mod">
        <pc:chgData name="Taylor, Christopher A. (CDC/NCIRD/CORVD)" userId="d5235d67-467a-405e-9bf3-737b0972e886" providerId="ADAL" clId="{93021E65-7AAC-4F7E-A208-59245577517D}" dt="2024-09-16T19:54:30.419" v="18" actId="20577"/>
        <pc:sldMkLst>
          <pc:docMk/>
          <pc:sldMk cId="3775072680" sldId="265"/>
        </pc:sldMkLst>
        <pc:spChg chg="mod">
          <ac:chgData name="Taylor, Christopher A. (CDC/NCIRD/CORVD)" userId="d5235d67-467a-405e-9bf3-737b0972e886" providerId="ADAL" clId="{93021E65-7AAC-4F7E-A208-59245577517D}" dt="2024-09-16T19:54:13.246" v="16" actId="20577"/>
          <ac:spMkLst>
            <pc:docMk/>
            <pc:sldMk cId="3775072680" sldId="265"/>
            <ac:spMk id="5" creationId="{1C4D845F-8E2C-2BE0-92CD-F4496B64AE62}"/>
          </ac:spMkLst>
        </pc:spChg>
        <pc:spChg chg="mod">
          <ac:chgData name="Taylor, Christopher A. (CDC/NCIRD/CORVD)" userId="d5235d67-467a-405e-9bf3-737b0972e886" providerId="ADAL" clId="{93021E65-7AAC-4F7E-A208-59245577517D}" dt="2024-09-16T19:54:17.898" v="17" actId="20577"/>
          <ac:spMkLst>
            <pc:docMk/>
            <pc:sldMk cId="3775072680" sldId="265"/>
            <ac:spMk id="6" creationId="{DE743452-5C8A-5D46-CAB0-917612BD00FC}"/>
          </ac:spMkLst>
        </pc:spChg>
        <pc:spChg chg="mod">
          <ac:chgData name="Taylor, Christopher A. (CDC/NCIRD/CORVD)" userId="d5235d67-467a-405e-9bf3-737b0972e886" providerId="ADAL" clId="{93021E65-7AAC-4F7E-A208-59245577517D}" dt="2024-09-16T19:53:51.090" v="13" actId="20577"/>
          <ac:spMkLst>
            <pc:docMk/>
            <pc:sldMk cId="3775072680" sldId="265"/>
            <ac:spMk id="8" creationId="{126FB4A5-5C1F-238D-C2A1-DBA19E87ECE5}"/>
          </ac:spMkLst>
        </pc:spChg>
        <pc:spChg chg="mod">
          <ac:chgData name="Taylor, Christopher A. (CDC/NCIRD/CORVD)" userId="d5235d67-467a-405e-9bf3-737b0972e886" providerId="ADAL" clId="{93021E65-7AAC-4F7E-A208-59245577517D}" dt="2024-09-16T19:54:30.419" v="18" actId="20577"/>
          <ac:spMkLst>
            <pc:docMk/>
            <pc:sldMk cId="3775072680" sldId="265"/>
            <ac:spMk id="10" creationId="{70AF18D4-585E-FE2B-1494-CC5B0C5F412D}"/>
          </ac:spMkLst>
        </pc:spChg>
        <pc:spChg chg="mod">
          <ac:chgData name="Taylor, Christopher A. (CDC/NCIRD/CORVD)" userId="d5235d67-467a-405e-9bf3-737b0972e886" providerId="ADAL" clId="{93021E65-7AAC-4F7E-A208-59245577517D}" dt="2024-09-16T19:54:03.203" v="15" actId="20577"/>
          <ac:spMkLst>
            <pc:docMk/>
            <pc:sldMk cId="3775072680" sldId="265"/>
            <ac:spMk id="11" creationId="{0AE72A67-760D-31D1-EFEB-6B6BE54A3253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7D2BFD-F164-1644-37F0-75A38AB3860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DF01C8-F50F-378D-D9AC-993BD49F21E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D10F30-5E05-4D16-44B3-646D5016DC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9E8D82-713B-8B71-78B9-A0939EEA7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95DED9-DE25-A246-6F53-9B26878AD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9345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F05757-1C2E-05F1-AD4E-4DBAD0A0C4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51EE432-079C-6E13-4764-0743DB2E74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4A7F5F-F717-56FD-9E87-F083161BA2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331093-8F8B-1227-EBB7-BD89F6B9A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C5C8744-6F21-C07C-39C3-0A8AA2E50E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74555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7BBE02-A271-5AC4-AED2-1CF4E6D90B8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2F11CB-90EE-8DD6-4ABA-CDAF64BEA8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E2682E-B7B6-BB4D-AA56-D7C33FDC0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1992AF-9C24-B981-2C87-8DA4A818DD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0EF124-0005-4C9A-3037-1D0F1CE74E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0373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4A8563-228E-CE17-33E2-563B7DA4E7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D92F544-67FA-FEE1-5659-29373CD379F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BCB65C-70CF-2C08-49EA-6B0713002D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FA81EDF-D3C0-E536-6BEF-98A8F3994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17AA05-C33F-6673-0DC8-C74BCEDD86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8564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A35631-7376-DE87-C57E-2EED8B1D1D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BCEE49C-5D8F-9964-AA14-270FFCDAADB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42EDC1-8C67-3E73-4638-109BD566B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8567B0-BF5F-D7C5-911F-E7059B281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A23A84B-1321-7095-08D9-C90206362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2675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A4ED11-F2CC-26AC-E2C5-2970AF8907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A3C0DF-1474-4B1E-B56D-5BD3CEC604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D393989-1A95-4BD8-EBE7-9F9657852DC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150E4D-2733-E1DA-B009-8833315CB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2DC59C-E55A-F610-4A23-4B89D5DE6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C69BAB7-EDD7-CF0A-3AEA-75D55B7FE0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046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4840E9-2230-9536-9FC5-2BBA167C19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7E92434-1342-C27E-58C8-A0107D6604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CE487C-88F0-88D5-9E3F-2B32D1693C0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B7DEF81-CC94-E285-2844-3BD41FA887F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5926095-7270-3BB5-D502-F363901337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3CB41A2-16BF-4E01-AEBD-6280450C8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0DDA9E7-FDEB-C009-E11F-89337EB961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39A7637-B0EE-2191-9C09-36DB8C3C3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4182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6DA63-BDC3-0BAC-9BB2-C4B0FFB1EF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7E70EBB-777C-1B1A-7993-B98281C743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A4115F7-9F0E-98CA-9BCE-93235C798C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4E3A1A6-1C82-7F04-DFE2-9D8E9D9778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65096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13C5111-80DC-3A56-9AF5-2C6519AA19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10819A0-6DAF-9E53-355D-4F7AD398B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5AF46DB-57FB-5FE5-802E-64F7281730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0020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463655-1AC1-6602-353D-E0CA6798CD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4B39CCE-34F4-66C1-8995-3F9E9A7D170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E1D724-50F9-2E5F-BEDE-0890AD3671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51A769F-1C95-6D13-48CC-1F020BF54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9CC6A8E-B843-F776-B2AD-36837A4581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B7981EF-8FDA-7905-3553-33F6A314E4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04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AD55B9-9CED-9DB8-DEEB-BC6958ECE7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CA79D22-88C8-3634-EB9F-52D97F2ECC2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B3EFAB-303E-0930-4DFB-13F5852BDC0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699A32-0296-20F2-C36D-61909605C4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1F3F4D-BF70-C411-3600-B0F08218B9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7D3DD2-2F3E-2C87-CF01-4367DC090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542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D0D29D-7344-7B83-655E-4C05B4A4B5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FB3579-45D3-75FA-AB2C-2F8AAB7EC0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7EF22D-E5D8-7125-1784-5114856175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ED40D-04BC-4754-9508-6C25687FAFD2}" type="datetimeFigureOut">
              <a:rPr lang="en-US" smtClean="0"/>
              <a:t>9/16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52EBAA-3605-5C14-1151-3EE8908DE5A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8B6804-C061-66A7-9AB3-74C1DD3553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602172-06EF-4586-979C-05DB2EECC6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867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C0CCFDF-CBAF-0C09-E957-65450CABEFF8}"/>
              </a:ext>
            </a:extLst>
          </p:cNvPr>
          <p:cNvGrpSpPr/>
          <p:nvPr/>
        </p:nvGrpSpPr>
        <p:grpSpPr>
          <a:xfrm>
            <a:off x="1178011" y="728018"/>
            <a:ext cx="9835978" cy="5401965"/>
            <a:chOff x="1178011" y="405711"/>
            <a:chExt cx="9835978" cy="5401965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E52FC9E2-4874-633B-352A-90DBBFA51C58}"/>
                </a:ext>
              </a:extLst>
            </p:cNvPr>
            <p:cNvSpPr/>
            <p:nvPr/>
          </p:nvSpPr>
          <p:spPr>
            <a:xfrm>
              <a:off x="1178011" y="405711"/>
              <a:ext cx="2842054" cy="297180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Is the presenting complaint upon admission related to one of the following?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Obstetrics/labor and delivery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Inpatient surgery or procedure (e.g., joint replacement, heart valve replacement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Psychiatric admission needing acute medical care (e.g., suicide attempt but needs medical intervention and admitted to a medical ward)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Trauma (e.g., car crash, fracture)</a:t>
              </a:r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1C4D845F-8E2C-2BE0-92CD-F4496B64AE62}"/>
                </a:ext>
              </a:extLst>
            </p:cNvPr>
            <p:cNvSpPr/>
            <p:nvPr/>
          </p:nvSpPr>
          <p:spPr>
            <a:xfrm>
              <a:off x="1178011" y="4935497"/>
              <a:ext cx="2842054" cy="871152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Mark the appropriate checkbox. Presenting complaint is not COVID-19–related.</a:t>
              </a: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E743452-5C8A-5D46-CAB0-917612BD00FC}"/>
                </a:ext>
              </a:extLst>
            </p:cNvPr>
            <p:cNvSpPr/>
            <p:nvPr/>
          </p:nvSpPr>
          <p:spPr>
            <a:xfrm>
              <a:off x="4674973" y="405712"/>
              <a:ext cx="2842054" cy="169493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Does the chief complaint and/or history of present illness mention this admission is due to any of the following?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Fever or respiratory illnes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COVID-19–like illness</a:t>
              </a:r>
            </a:p>
            <a:p>
              <a:pPr marL="285750" indent="-285750">
                <a:buFont typeface="Arial" panose="020B0604020202020204" pitchFamily="34" charset="0"/>
                <a:buChar char="•"/>
              </a:pPr>
              <a:r>
                <a:rPr lang="en-US" sz="1400" dirty="0">
                  <a:solidFill>
                    <a:schemeClr val="tx1"/>
                  </a:solidFill>
                </a:rPr>
                <a:t>Suspicion for COVID-19</a:t>
              </a:r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126FB4A5-5C1F-238D-C2A1-DBA19E87ECE5}"/>
                </a:ext>
              </a:extLst>
            </p:cNvPr>
            <p:cNvSpPr/>
            <p:nvPr/>
          </p:nvSpPr>
          <p:spPr>
            <a:xfrm>
              <a:off x="4674973" y="4158050"/>
              <a:ext cx="2842054" cy="1649626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Mark </a:t>
              </a:r>
              <a:r>
                <a:rPr lang="en-US" sz="1400" i="1" dirty="0">
                  <a:solidFill>
                    <a:schemeClr val="tx1"/>
                  </a:solidFill>
                </a:rPr>
                <a:t>Other, specify</a:t>
              </a:r>
              <a:r>
                <a:rPr lang="en-US" sz="1400" dirty="0">
                  <a:solidFill>
                    <a:schemeClr val="tx1"/>
                  </a:solidFill>
                </a:rPr>
                <a:t> and enter free text. If multiple reasons for admission, separate with commas.</a:t>
              </a:r>
            </a:p>
            <a:p>
              <a:r>
                <a:rPr lang="en-US" sz="1400" dirty="0">
                  <a:solidFill>
                    <a:schemeClr val="tx1"/>
                  </a:solidFill>
                </a:rPr>
                <a:t>Machine-learning algorithm and clinician review, if necessary, will be applied, using criteria in Table S1.</a:t>
              </a: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6D3825F-43BA-27D0-DE81-5B30E0B7C140}"/>
                </a:ext>
              </a:extLst>
            </p:cNvPr>
            <p:cNvSpPr/>
            <p:nvPr/>
          </p:nvSpPr>
          <p:spPr>
            <a:xfrm>
              <a:off x="4674973" y="2536225"/>
              <a:ext cx="2842054" cy="118624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Does the medical chart specifically indicate that SARS-CoV-2 was an incidental finding or that the admission was likely not COVID-19-related?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70AF18D4-585E-FE2B-1494-CC5B0C5F412D}"/>
                </a:ext>
              </a:extLst>
            </p:cNvPr>
            <p:cNvSpPr/>
            <p:nvPr/>
          </p:nvSpPr>
          <p:spPr>
            <a:xfrm>
              <a:off x="8171935" y="405712"/>
              <a:ext cx="2842054" cy="871153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Mark the </a:t>
              </a:r>
              <a:r>
                <a:rPr lang="en-US" sz="1400" i="1" dirty="0">
                  <a:solidFill>
                    <a:schemeClr val="tx1"/>
                  </a:solidFill>
                </a:rPr>
                <a:t>COVID-19–related illness checkbox</a:t>
              </a:r>
              <a:r>
                <a:rPr lang="en-US" sz="1400" dirty="0">
                  <a:solidFill>
                    <a:schemeClr val="tx1"/>
                  </a:solidFill>
                </a:rPr>
                <a:t>. Presenting complaint is COVID-19–related.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0AE72A67-760D-31D1-EFEB-6B6BE54A3253}"/>
                </a:ext>
              </a:extLst>
            </p:cNvPr>
            <p:cNvSpPr/>
            <p:nvPr/>
          </p:nvSpPr>
          <p:spPr>
            <a:xfrm>
              <a:off x="8171935" y="2536224"/>
              <a:ext cx="2842054" cy="118624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Mark </a:t>
              </a:r>
              <a:r>
                <a:rPr lang="en-US" sz="1400" i="1" dirty="0">
                  <a:solidFill>
                    <a:schemeClr val="tx1"/>
                  </a:solidFill>
                </a:rPr>
                <a:t>Other, specify</a:t>
              </a:r>
              <a:r>
                <a:rPr lang="en-US" sz="1400" dirty="0">
                  <a:solidFill>
                    <a:schemeClr val="tx1"/>
                  </a:solidFill>
                </a:rPr>
                <a:t> and enter “[reason for admission], admission likely not COVID-19–related per notes.”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E412C56B-7BFA-A7F3-06C2-F5405B7A8EE6}"/>
                </a:ext>
              </a:extLst>
            </p:cNvPr>
            <p:cNvCxnSpPr>
              <a:stCxn id="4" idx="2"/>
              <a:endCxn id="5" idx="0"/>
            </p:cNvCxnSpPr>
            <p:nvPr/>
          </p:nvCxnSpPr>
          <p:spPr>
            <a:xfrm>
              <a:off x="2599038" y="3377512"/>
              <a:ext cx="0" cy="1557985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>
              <a:extLst>
                <a:ext uri="{FF2B5EF4-FFF2-40B4-BE49-F238E27FC236}">
                  <a16:creationId xmlns:a16="http://schemas.microsoft.com/office/drawing/2014/main" id="{2D1C755C-EF89-1B03-B6D6-683FF5C799C6}"/>
                </a:ext>
              </a:extLst>
            </p:cNvPr>
            <p:cNvCxnSpPr>
              <a:cxnSpLocks/>
              <a:endCxn id="6" idx="1"/>
            </p:cNvCxnSpPr>
            <p:nvPr/>
          </p:nvCxnSpPr>
          <p:spPr>
            <a:xfrm>
              <a:off x="4020065" y="1253180"/>
              <a:ext cx="654908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11EC0D9A-CE46-8730-5CA1-E6903D0A20F1}"/>
                </a:ext>
              </a:extLst>
            </p:cNvPr>
            <p:cNvCxnSpPr>
              <a:stCxn id="6" idx="2"/>
              <a:endCxn id="9" idx="0"/>
            </p:cNvCxnSpPr>
            <p:nvPr/>
          </p:nvCxnSpPr>
          <p:spPr>
            <a:xfrm>
              <a:off x="6096000" y="2100648"/>
              <a:ext cx="0" cy="435577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Connector 18">
              <a:extLst>
                <a:ext uri="{FF2B5EF4-FFF2-40B4-BE49-F238E27FC236}">
                  <a16:creationId xmlns:a16="http://schemas.microsoft.com/office/drawing/2014/main" id="{95278B33-C8AC-002E-2E24-E2D536B0267B}"/>
                </a:ext>
              </a:extLst>
            </p:cNvPr>
            <p:cNvCxnSpPr>
              <a:cxnSpLocks/>
              <a:stCxn id="9" idx="2"/>
              <a:endCxn id="8" idx="0"/>
            </p:cNvCxnSpPr>
            <p:nvPr/>
          </p:nvCxnSpPr>
          <p:spPr>
            <a:xfrm>
              <a:off x="6096000" y="3722473"/>
              <a:ext cx="0" cy="435577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0CB6C2DC-A090-692B-C37E-D6AB10F66210}"/>
                </a:ext>
              </a:extLst>
            </p:cNvPr>
            <p:cNvCxnSpPr>
              <a:cxnSpLocks/>
              <a:endCxn id="10" idx="1"/>
            </p:cNvCxnSpPr>
            <p:nvPr/>
          </p:nvCxnSpPr>
          <p:spPr>
            <a:xfrm>
              <a:off x="7517027" y="841289"/>
              <a:ext cx="654908" cy="0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Straight Connector 24">
              <a:extLst>
                <a:ext uri="{FF2B5EF4-FFF2-40B4-BE49-F238E27FC236}">
                  <a16:creationId xmlns:a16="http://schemas.microsoft.com/office/drawing/2014/main" id="{454E00AF-7519-8434-FA11-393DA1323D26}"/>
                </a:ext>
              </a:extLst>
            </p:cNvPr>
            <p:cNvCxnSpPr>
              <a:cxnSpLocks/>
              <a:stCxn id="9" idx="3"/>
              <a:endCxn id="11" idx="1"/>
            </p:cNvCxnSpPr>
            <p:nvPr/>
          </p:nvCxnSpPr>
          <p:spPr>
            <a:xfrm flipV="1">
              <a:off x="7517027" y="3129348"/>
              <a:ext cx="654908" cy="1"/>
            </a:xfrm>
            <a:prstGeom prst="line">
              <a:avLst/>
            </a:prstGeom>
            <a:ln>
              <a:solidFill>
                <a:schemeClr val="tx1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id="{01B60C88-D005-3043-6BF3-E5D56D5CAC3D}"/>
                </a:ext>
              </a:extLst>
            </p:cNvPr>
            <p:cNvSpPr/>
            <p:nvPr/>
          </p:nvSpPr>
          <p:spPr>
            <a:xfrm>
              <a:off x="8171935" y="4786189"/>
              <a:ext cx="2842054" cy="102046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sz="1400" dirty="0">
                  <a:solidFill>
                    <a:schemeClr val="tx1"/>
                  </a:solidFill>
                </a:rPr>
                <a:t>If presenting complaint cannot be determined or chart is unavailable, select </a:t>
              </a:r>
              <a:r>
                <a:rPr lang="en-US" sz="1400" i="1" dirty="0">
                  <a:solidFill>
                    <a:schemeClr val="tx1"/>
                  </a:solidFill>
                </a:rPr>
                <a:t>Unknown</a:t>
              </a:r>
              <a:r>
                <a:rPr lang="en-US" sz="1400" dirty="0">
                  <a:solidFill>
                    <a:schemeClr val="tx1"/>
                  </a:solidFill>
                </a:rPr>
                <a:t>.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28AFE970-D929-D668-73DD-B12D562CBCFE}"/>
                </a:ext>
              </a:extLst>
            </p:cNvPr>
            <p:cNvSpPr txBox="1"/>
            <p:nvPr/>
          </p:nvSpPr>
          <p:spPr>
            <a:xfrm>
              <a:off x="2454875" y="3910912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YES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73CA8B6-9D51-924B-22DB-624CF48B3257}"/>
                </a:ext>
              </a:extLst>
            </p:cNvPr>
            <p:cNvSpPr txBox="1"/>
            <p:nvPr/>
          </p:nvSpPr>
          <p:spPr>
            <a:xfrm>
              <a:off x="5935362" y="2179936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NO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52AC1DFE-7FF0-39F4-8972-8D275461F483}"/>
                </a:ext>
              </a:extLst>
            </p:cNvPr>
            <p:cNvSpPr txBox="1"/>
            <p:nvPr/>
          </p:nvSpPr>
          <p:spPr>
            <a:xfrm>
              <a:off x="5935362" y="3803307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NO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5453C7CB-E4D3-8C68-2079-130E2E2548A4}"/>
                </a:ext>
              </a:extLst>
            </p:cNvPr>
            <p:cNvSpPr txBox="1"/>
            <p:nvPr/>
          </p:nvSpPr>
          <p:spPr>
            <a:xfrm>
              <a:off x="7490252" y="564289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YES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D1AEF9D-0EB1-83BE-DECE-0420D7A98B64}"/>
                </a:ext>
              </a:extLst>
            </p:cNvPr>
            <p:cNvSpPr txBox="1"/>
            <p:nvPr/>
          </p:nvSpPr>
          <p:spPr>
            <a:xfrm>
              <a:off x="7484073" y="2852347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YES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939E4297-9C0E-1518-351F-2CEA8243D666}"/>
                </a:ext>
              </a:extLst>
            </p:cNvPr>
            <p:cNvSpPr txBox="1"/>
            <p:nvPr/>
          </p:nvSpPr>
          <p:spPr>
            <a:xfrm>
              <a:off x="4006678" y="988536"/>
              <a:ext cx="6755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/>
                <a:t>N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7750726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4E73DB1B3A82240AAE4616B9E408885" ma:contentTypeVersion="15" ma:contentTypeDescription="Create a new document." ma:contentTypeScope="" ma:versionID="31a882a0ca9e78c7185939a02ab2d4e7">
  <xsd:schema xmlns:xsd="http://www.w3.org/2001/XMLSchema" xmlns:xs="http://www.w3.org/2001/XMLSchema" xmlns:p="http://schemas.microsoft.com/office/2006/metadata/properties" xmlns:ns2="559fa04e-dbf9-4202-90f7-f9635d81742e" xmlns:ns3="11258c1b-5a8e-46e3-bab0-95e92e5e9835" targetNamespace="http://schemas.microsoft.com/office/2006/metadata/properties" ma:root="true" ma:fieldsID="059323d942d83956d1b8c28356328293" ns2:_="" ns3:_="">
    <xsd:import namespace="559fa04e-dbf9-4202-90f7-f9635d81742e"/>
    <xsd:import namespace="11258c1b-5a8e-46e3-bab0-95e92e5e9835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3:SharedWithUsers" minOccurs="0"/>
                <xsd:element ref="ns3:SharedWithDetails" minOccurs="0"/>
                <xsd:element ref="ns2:MediaLengthInSeconds" minOccurs="0"/>
                <xsd:element ref="ns2:MediaServiceLocation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59fa04e-dbf9-4202-90f7-f9635d81742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1" nillable="true" ma:taxonomy="true" ma:internalName="lcf76f155ced4ddcb4097134ff3c332f" ma:taxonomyFieldName="MediaServiceImageTags" ma:displayName="Image Tags" ma:readOnly="false" ma:fieldId="{5cf76f15-5ced-4ddc-b409-7134ff3c332f}" ma:taxonomyMulti="true" ma:sspId="9353dbe8-8260-4ccf-8219-3d2995e6fa15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3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dexed="true" ma:internalName="MediaServiceLocation" ma:readOnly="true">
      <xsd:simpleType>
        <xsd:restriction base="dms:Text"/>
      </xsd:simpleType>
    </xsd:element>
    <xsd:element name="MediaServiceObjectDetectorVersions" ma:index="21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1258c1b-5a8e-46e3-bab0-95e92e5e9835" elementFormDefault="qualified">
    <xsd:import namespace="http://schemas.microsoft.com/office/2006/documentManagement/types"/>
    <xsd:import namespace="http://schemas.microsoft.com/office/infopath/2007/PartnerControls"/>
    <xsd:element name="TaxCatchAll" ma:index="12" nillable="true" ma:displayName="Taxonomy Catch All Column" ma:hidden="true" ma:list="{b68e2f84-bb39-424c-8323-bdb2ddd19ae9}" ma:internalName="TaxCatchAll" ma:showField="CatchAllData" ma:web="11258c1b-5a8e-46e3-bab0-95e92e5e9835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  <xsd:element name="SharedWithUsers" ma:index="17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8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559fa04e-dbf9-4202-90f7-f9635d81742e">
      <Terms xmlns="http://schemas.microsoft.com/office/infopath/2007/PartnerControls"/>
    </lcf76f155ced4ddcb4097134ff3c332f>
    <TaxCatchAll xmlns="11258c1b-5a8e-46e3-bab0-95e92e5e9835" xsi:nil="true"/>
  </documentManagement>
</p:properties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76C5CFE5-D3E0-4989-ABFD-88A07D49D851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59fa04e-dbf9-4202-90f7-f9635d81742e"/>
    <ds:schemaRef ds:uri="11258c1b-5a8e-46e3-bab0-95e92e5e9835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CF8ABD49-C355-49A4-B097-CDCE39373539}">
  <ds:schemaRefs>
    <ds:schemaRef ds:uri="http://schemas.microsoft.com/office/2006/metadata/properties"/>
    <ds:schemaRef ds:uri="http://schemas.microsoft.com/office/infopath/2007/PartnerControls"/>
    <ds:schemaRef ds:uri="559fa04e-dbf9-4202-90f7-f9635d81742e"/>
    <ds:schemaRef ds:uri="11258c1b-5a8e-46e3-bab0-95e92e5e9835"/>
  </ds:schemaRefs>
</ds:datastoreItem>
</file>

<file path=customXml/itemProps3.xml><?xml version="1.0" encoding="utf-8"?>
<ds:datastoreItem xmlns:ds="http://schemas.openxmlformats.org/officeDocument/2006/customXml" ds:itemID="{92C3A90B-319D-4311-80FB-B38FB46DC06F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9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Christopher A. (CDC/NCIRD/CORVD)</dc:creator>
  <cp:lastModifiedBy>Taylor, Christopher A. (CDC/NCIRD/CORVD)</cp:lastModifiedBy>
  <cp:revision>1</cp:revision>
  <dcterms:created xsi:type="dcterms:W3CDTF">2024-09-16T15:08:16Z</dcterms:created>
  <dcterms:modified xsi:type="dcterms:W3CDTF">2024-09-16T19:54:3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b94a7b8-f06c-4dfe-bdcc-9b548fd58c31_Enabled">
    <vt:lpwstr>true</vt:lpwstr>
  </property>
  <property fmtid="{D5CDD505-2E9C-101B-9397-08002B2CF9AE}" pid="3" name="MSIP_Label_7b94a7b8-f06c-4dfe-bdcc-9b548fd58c31_SetDate">
    <vt:lpwstr>2024-09-16T15:11:03Z</vt:lpwstr>
  </property>
  <property fmtid="{D5CDD505-2E9C-101B-9397-08002B2CF9AE}" pid="4" name="MSIP_Label_7b94a7b8-f06c-4dfe-bdcc-9b548fd58c31_Method">
    <vt:lpwstr>Privileged</vt:lpwstr>
  </property>
  <property fmtid="{D5CDD505-2E9C-101B-9397-08002B2CF9AE}" pid="5" name="MSIP_Label_7b94a7b8-f06c-4dfe-bdcc-9b548fd58c31_Name">
    <vt:lpwstr>7b94a7b8-f06c-4dfe-bdcc-9b548fd58c31</vt:lpwstr>
  </property>
  <property fmtid="{D5CDD505-2E9C-101B-9397-08002B2CF9AE}" pid="6" name="MSIP_Label_7b94a7b8-f06c-4dfe-bdcc-9b548fd58c31_SiteId">
    <vt:lpwstr>9ce70869-60db-44fd-abe8-d2767077fc8f</vt:lpwstr>
  </property>
  <property fmtid="{D5CDD505-2E9C-101B-9397-08002B2CF9AE}" pid="7" name="MSIP_Label_7b94a7b8-f06c-4dfe-bdcc-9b548fd58c31_ActionId">
    <vt:lpwstr>72900da1-a0ea-4999-a9c7-020771c59f78</vt:lpwstr>
  </property>
  <property fmtid="{D5CDD505-2E9C-101B-9397-08002B2CF9AE}" pid="8" name="MSIP_Label_7b94a7b8-f06c-4dfe-bdcc-9b548fd58c31_ContentBits">
    <vt:lpwstr>0</vt:lpwstr>
  </property>
  <property fmtid="{D5CDD505-2E9C-101B-9397-08002B2CF9AE}" pid="9" name="ContentTypeId">
    <vt:lpwstr>0x010100E4E73DB1B3A82240AAE4616B9E408885</vt:lpwstr>
  </property>
  <property fmtid="{D5CDD505-2E9C-101B-9397-08002B2CF9AE}" pid="10" name="MediaServiceImageTags">
    <vt:lpwstr/>
  </property>
</Properties>
</file>